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57" r:id="rId3"/>
    <p:sldId id="263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205B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2F2BA7-4E69-4C5C-B13B-B7A84266366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06AAB86-1186-4E3A-8D55-6DED94195B4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C89AEE-39F7-4004-9159-C96E2EDB55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CD502-45B7-4587-B434-47CECF1DB1FC}" type="datetimeFigureOut">
              <a:rPr lang="en-GB" smtClean="0"/>
              <a:t>01/03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5EBE1B-BB8A-49EF-A3CB-BD2C0C4ECD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442CBE-8035-4FF5-92E5-1BB6CF3F0C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21D69-50E0-4BC4-A945-46A534C0E81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86594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9717E6-9825-4577-BB44-85CA779DED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32C9FED-AF14-4359-A439-85B77363F6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84EF20-320B-44E8-B609-C881C3A522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CD502-45B7-4587-B434-47CECF1DB1FC}" type="datetimeFigureOut">
              <a:rPr lang="en-GB" smtClean="0"/>
              <a:t>01/03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6C9C98-4402-4A14-A6A3-2534397F70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1BF29E-2B09-4287-9FAE-E9608CCB9D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21D69-50E0-4BC4-A945-46A534C0E81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66732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24D159E-7F39-433A-8893-86FD38AAF15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D751DE8-1785-4CF5-BD4E-434CD6297E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58E4DA-9142-4A05-9CF9-FBF17046D1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CD502-45B7-4587-B434-47CECF1DB1FC}" type="datetimeFigureOut">
              <a:rPr lang="en-GB" smtClean="0"/>
              <a:t>01/03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18AA2C-0EC0-4AA8-874E-C622E54C6B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28F2C2-4BD6-4474-970C-DF98DB21B2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21D69-50E0-4BC4-A945-46A534C0E81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63568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EFEA83-0BF5-4AB9-9917-751A5D8BAD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754408-A8EB-40E7-8FCF-43CF0940745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96F221-9283-4059-B6F6-E0E60F7ACE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CD502-45B7-4587-B434-47CECF1DB1FC}" type="datetimeFigureOut">
              <a:rPr lang="en-GB" smtClean="0"/>
              <a:t>01/03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EF7B63-845B-4610-99A3-4515051F8F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DA8247-83C9-4A82-880A-703C8112A6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21D69-50E0-4BC4-A945-46A534C0E81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563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1D4687-82AD-4106-93C4-DFC5B34D91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BF2D2DB-F39A-4D61-91CC-5E82ED62B0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CEB546-CB74-4D6F-9F1F-8044141980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CD502-45B7-4587-B434-47CECF1DB1FC}" type="datetimeFigureOut">
              <a:rPr lang="en-GB" smtClean="0"/>
              <a:t>01/03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3E9C0F-2F95-467F-AAA2-0705D028B3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C693F6-F702-4AD7-8D31-288858239F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21D69-50E0-4BC4-A945-46A534C0E81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04919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462D34-67A1-4173-BDBC-0DEBD2EF25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0B45B7-8CFF-4E68-A047-53F12276C34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8EE2562-E081-4563-A440-6210FAA118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0865B12-90FC-45A7-AB4E-0C96A2ECA8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CD502-45B7-4587-B434-47CECF1DB1FC}" type="datetimeFigureOut">
              <a:rPr lang="en-GB" smtClean="0"/>
              <a:t>01/03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181874-1504-4456-9B7A-97E1AD320A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EF01E8-3155-49DB-90ED-2610783788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21D69-50E0-4BC4-A945-46A534C0E81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84362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521408-8EE0-4612-85F5-F42E60C185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19792EC-6E54-40A8-94DE-30AF46EC51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0C96D54-DEE3-4B80-894F-FD42BBF66B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24D6D84-565A-4FE0-913C-3CFC93C9217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5A96709-9EA5-459E-AA04-AFC3F634C12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22F92D8-1065-4704-956C-B1A53AF4F4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CD502-45B7-4587-B434-47CECF1DB1FC}" type="datetimeFigureOut">
              <a:rPr lang="en-GB" smtClean="0"/>
              <a:t>01/03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CBFD8D9-8EBA-4876-AB50-EC56572898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EBFB88A-9BF3-47D0-8999-4346C76EA9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21D69-50E0-4BC4-A945-46A534C0E81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92179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386DBC-CB4C-4EF7-B02B-C51A62E541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E483960-A247-4DE0-86F6-417C2DBFBF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CD502-45B7-4587-B434-47CECF1DB1FC}" type="datetimeFigureOut">
              <a:rPr lang="en-GB" smtClean="0"/>
              <a:t>01/03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4B5DBD8-F1D2-4360-A786-76B0FBB058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B36D73F-8A39-4D93-8CB3-17045B8004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21D69-50E0-4BC4-A945-46A534C0E81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57322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B660DEE-B977-41C4-AB87-0FB906B1FE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CD502-45B7-4587-B434-47CECF1DB1FC}" type="datetimeFigureOut">
              <a:rPr lang="en-GB" smtClean="0"/>
              <a:t>01/03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0EEA16E-9864-48F1-8BBD-5DF3D44981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F9EC70E-9815-478F-BAA5-C6E41B0E1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21D69-50E0-4BC4-A945-46A534C0E81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98017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356C54-236C-4CA5-A2CD-D2BA08AFCB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34BD6C-B64A-427E-9BFB-AE7B76F7D8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20E9A51-9A3E-42A3-BCD1-ED6CEDF94B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AD9B0F0-BD39-48A2-AF50-FAF369B098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CD502-45B7-4587-B434-47CECF1DB1FC}" type="datetimeFigureOut">
              <a:rPr lang="en-GB" smtClean="0"/>
              <a:t>01/03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01638C5-F2BF-4C00-8D6D-409733C173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8F56C3-D5A2-489F-895C-7CE0F253A0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21D69-50E0-4BC4-A945-46A534C0E81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12371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80C3C5-97CF-42BC-A67F-2B5AD8E042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36C21AC-4CF8-40F2-8166-B6588A07D43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A86C5CC-47D7-4910-A71A-3DCF1ADAED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FC94FF-80B3-4BDD-9DF2-C8A60F8E45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CD502-45B7-4587-B434-47CECF1DB1FC}" type="datetimeFigureOut">
              <a:rPr lang="en-GB" smtClean="0"/>
              <a:t>01/03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3CAE83C-B983-4D90-A264-17834DFFAA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67B3A1-B901-4EDD-BE73-2E8F0E85C7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21D69-50E0-4BC4-A945-46A534C0E81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75293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ECCE030-DC2D-408D-BFEC-40B03D3FFC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B784F2F-D499-4ABF-9D51-BC850B69F4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2A2B8E-1D2F-46B8-83F9-DEE78EC1E7B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1CD502-45B7-4587-B434-47CECF1DB1FC}" type="datetimeFigureOut">
              <a:rPr lang="en-GB" smtClean="0"/>
              <a:t>01/03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744015-B7CC-4253-BCEC-5A264F8D673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934FC2-FE4D-4AFA-A848-2848F141502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821D69-50E0-4BC4-A945-46A534C0E81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06677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7" Type="http://schemas.openxmlformats.org/officeDocument/2006/relationships/image" Target="../media/image12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emf"/><Relationship Id="rId5" Type="http://schemas.openxmlformats.org/officeDocument/2006/relationships/image" Target="../media/image10.emf"/><Relationship Id="rId4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7" Type="http://schemas.openxmlformats.org/officeDocument/2006/relationships/image" Target="../media/image18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emf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7" Type="http://schemas.openxmlformats.org/officeDocument/2006/relationships/image" Target="../media/image24.emf"/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emf"/><Relationship Id="rId5" Type="http://schemas.openxmlformats.org/officeDocument/2006/relationships/image" Target="../media/image22.emf"/><Relationship Id="rId4" Type="http://schemas.openxmlformats.org/officeDocument/2006/relationships/image" Target="../media/image21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7" Type="http://schemas.openxmlformats.org/officeDocument/2006/relationships/image" Target="../media/image30.emf"/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emf"/><Relationship Id="rId5" Type="http://schemas.openxmlformats.org/officeDocument/2006/relationships/image" Target="../media/image28.emf"/><Relationship Id="rId4" Type="http://schemas.openxmlformats.org/officeDocument/2006/relationships/image" Target="../media/image27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emf"/><Relationship Id="rId7" Type="http://schemas.openxmlformats.org/officeDocument/2006/relationships/image" Target="../media/image36.emf"/><Relationship Id="rId2" Type="http://schemas.openxmlformats.org/officeDocument/2006/relationships/image" Target="../media/image3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emf"/><Relationship Id="rId5" Type="http://schemas.openxmlformats.org/officeDocument/2006/relationships/image" Target="../media/image34.emf"/><Relationship Id="rId4" Type="http://schemas.openxmlformats.org/officeDocument/2006/relationships/image" Target="../media/image3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B7A70AC-11BB-4C86-A753-EA47BE1BEF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50500" y="3429000"/>
            <a:ext cx="3998548" cy="27000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FF7A955F-41AD-41F3-8504-5D62458520C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0400" y="944059"/>
            <a:ext cx="3998548" cy="27000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ADCD1F98-230D-4B58-8FBB-138780A244E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55450" y="944059"/>
            <a:ext cx="3998548" cy="270000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FC9A4784-F08D-4A98-BB46-885CA03B892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50500" y="944059"/>
            <a:ext cx="3998548" cy="270000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157F2B4B-210D-4F44-BCB8-B184B3BCA45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60400" y="3429000"/>
            <a:ext cx="3998548" cy="2700000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6708ECE2-BD39-403E-975E-D7DBFB97856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55450" y="3429000"/>
            <a:ext cx="3998548" cy="2700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4F537812-CB6C-48B1-BE0C-240847DA3746}"/>
              </a:ext>
            </a:extLst>
          </p:cNvPr>
          <p:cNvSpPr txBox="1"/>
          <p:nvPr/>
        </p:nvSpPr>
        <p:spPr>
          <a:xfrm>
            <a:off x="1543247" y="176169"/>
            <a:ext cx="910550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Examples of the comparisons between measured and predicted leaf net photosynthesis rate</a:t>
            </a:r>
          </a:p>
          <a:p>
            <a:endParaRPr lang="en-GB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D316B54-2979-4DCB-81F7-5391E8B80B8C}"/>
              </a:ext>
            </a:extLst>
          </p:cNvPr>
          <p:cNvSpPr txBox="1"/>
          <p:nvPr/>
        </p:nvSpPr>
        <p:spPr>
          <a:xfrm>
            <a:off x="4919330" y="583834"/>
            <a:ext cx="2197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ucumber cv. ‘</a:t>
            </a:r>
            <a:r>
              <a:rPr lang="en-GB" dirty="0" err="1"/>
              <a:t>Mewa</a:t>
            </a:r>
            <a:r>
              <a:rPr lang="en-GB" dirty="0"/>
              <a:t>’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65E4ADB5-62EB-4AC4-A56F-91AA659BD487}"/>
              </a:ext>
            </a:extLst>
          </p:cNvPr>
          <p:cNvGrpSpPr/>
          <p:nvPr/>
        </p:nvGrpSpPr>
        <p:grpSpPr>
          <a:xfrm>
            <a:off x="6095999" y="6245387"/>
            <a:ext cx="3486745" cy="369332"/>
            <a:chOff x="7747798" y="6312499"/>
            <a:chExt cx="3486745" cy="369332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B59DC06-18D4-4630-9153-A75E81201426}"/>
                </a:ext>
              </a:extLst>
            </p:cNvPr>
            <p:cNvSpPr txBox="1"/>
            <p:nvPr/>
          </p:nvSpPr>
          <p:spPr>
            <a:xfrm>
              <a:off x="7855798" y="6312499"/>
              <a:ext cx="337874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Predicted leaf photosynthesis rate</a:t>
              </a:r>
            </a:p>
          </p:txBody>
        </p:sp>
        <p:sp>
          <p:nvSpPr>
            <p:cNvPr id="11" name="Oval 10">
              <a:extLst>
                <a:ext uri="{FF2B5EF4-FFF2-40B4-BE49-F238E27FC236}">
                  <a16:creationId xmlns:a16="http://schemas.microsoft.com/office/drawing/2014/main" id="{4BC7E0D0-80BE-4F53-9068-5110E706B178}"/>
                </a:ext>
              </a:extLst>
            </p:cNvPr>
            <p:cNvSpPr/>
            <p:nvPr/>
          </p:nvSpPr>
          <p:spPr>
            <a:xfrm>
              <a:off x="7747798" y="6443165"/>
              <a:ext cx="108000" cy="108000"/>
            </a:xfrm>
            <a:prstGeom prst="ellipse">
              <a:avLst/>
            </a:prstGeom>
            <a:noFill/>
            <a:ln>
              <a:solidFill>
                <a:srgbClr val="1205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8AD511A2-4552-4C82-ACA9-D052977D5267}"/>
              </a:ext>
            </a:extLst>
          </p:cNvPr>
          <p:cNvSpPr txBox="1"/>
          <p:nvPr/>
        </p:nvSpPr>
        <p:spPr>
          <a:xfrm>
            <a:off x="2169460" y="6245387"/>
            <a:ext cx="36008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FF0000"/>
                </a:solidFill>
              </a:rPr>
              <a:t>+</a:t>
            </a:r>
            <a:r>
              <a:rPr lang="en-GB" dirty="0"/>
              <a:t> Measured leaf photosynthesis rat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6771ED5-9640-4664-886E-3C8DC3F17B47}"/>
              </a:ext>
            </a:extLst>
          </p:cNvPr>
          <p:cNvSpPr txBox="1"/>
          <p:nvPr/>
        </p:nvSpPr>
        <p:spPr>
          <a:xfrm>
            <a:off x="562062" y="1300294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14695AC-617A-4C53-995F-62E08BA63F4A}"/>
              </a:ext>
            </a:extLst>
          </p:cNvPr>
          <p:cNvSpPr txBox="1"/>
          <p:nvPr/>
        </p:nvSpPr>
        <p:spPr>
          <a:xfrm>
            <a:off x="4560611" y="1302325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62CBF08-8929-4866-AD48-8063988139A1}"/>
              </a:ext>
            </a:extLst>
          </p:cNvPr>
          <p:cNvSpPr txBox="1"/>
          <p:nvPr/>
        </p:nvSpPr>
        <p:spPr>
          <a:xfrm>
            <a:off x="8559160" y="1300294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53AE25A-C632-4DC6-884D-93C00E64CC0A}"/>
              </a:ext>
            </a:extLst>
          </p:cNvPr>
          <p:cNvSpPr txBox="1"/>
          <p:nvPr/>
        </p:nvSpPr>
        <p:spPr>
          <a:xfrm>
            <a:off x="554967" y="3760446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4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10CDA54-2DA5-4B58-809E-0CE163D40E5F}"/>
              </a:ext>
            </a:extLst>
          </p:cNvPr>
          <p:cNvSpPr txBox="1"/>
          <p:nvPr/>
        </p:nvSpPr>
        <p:spPr>
          <a:xfrm>
            <a:off x="4553516" y="3762477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5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5B33F1B-B0D0-46E7-869A-890B10A57BA7}"/>
              </a:ext>
            </a:extLst>
          </p:cNvPr>
          <p:cNvSpPr txBox="1"/>
          <p:nvPr/>
        </p:nvSpPr>
        <p:spPr>
          <a:xfrm>
            <a:off x="8552065" y="3760446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6</a:t>
            </a:r>
          </a:p>
        </p:txBody>
      </p:sp>
    </p:spTree>
    <p:extLst>
      <p:ext uri="{BB962C8B-B14F-4D97-AF65-F5344CB8AC3E}">
        <p14:creationId xmlns:p14="http://schemas.microsoft.com/office/powerpoint/2010/main" val="32547024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F537812-CB6C-48B1-BE0C-240847DA3746}"/>
              </a:ext>
            </a:extLst>
          </p:cNvPr>
          <p:cNvSpPr txBox="1"/>
          <p:nvPr/>
        </p:nvSpPr>
        <p:spPr>
          <a:xfrm>
            <a:off x="1543247" y="176169"/>
            <a:ext cx="910550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Examples of the comparisons between measured and predicted leaf net photosynthesis rate</a:t>
            </a:r>
          </a:p>
          <a:p>
            <a:endParaRPr lang="en-GB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D316B54-2979-4DCB-81F7-5391E8B80B8C}"/>
              </a:ext>
            </a:extLst>
          </p:cNvPr>
          <p:cNvSpPr txBox="1"/>
          <p:nvPr/>
        </p:nvSpPr>
        <p:spPr>
          <a:xfrm>
            <a:off x="4919330" y="583834"/>
            <a:ext cx="23533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omato cv. ‘</a:t>
            </a:r>
            <a:r>
              <a:rPr lang="en-GB" dirty="0" err="1"/>
              <a:t>Sweeterno</a:t>
            </a:r>
            <a:r>
              <a:rPr lang="en-GB" dirty="0"/>
              <a:t>’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4501765-89B4-460F-8B58-744BB755D4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400" y="944059"/>
            <a:ext cx="3998549" cy="2700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73D26A7-BECA-4BD8-A092-7B39A67F61E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58949" y="944059"/>
            <a:ext cx="3998549" cy="27000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5FFF705-A578-498D-8EB1-2A7CCFE888F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57498" y="944059"/>
            <a:ext cx="3998549" cy="2700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FB7575B-DEA1-469F-8F46-AC929C562C5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0400" y="3429000"/>
            <a:ext cx="3998548" cy="27000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3189162C-D190-4F42-AD21-F493DF1EB6E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58948" y="3429000"/>
            <a:ext cx="3998547" cy="2700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9EEE2695-D2E0-4AD9-813D-22573065C7D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157495" y="3429000"/>
            <a:ext cx="3998548" cy="2700000"/>
          </a:xfrm>
          <a:prstGeom prst="rect">
            <a:avLst/>
          </a:prstGeom>
        </p:spPr>
      </p:pic>
      <p:grpSp>
        <p:nvGrpSpPr>
          <p:cNvPr id="12" name="Group 11">
            <a:extLst>
              <a:ext uri="{FF2B5EF4-FFF2-40B4-BE49-F238E27FC236}">
                <a16:creationId xmlns:a16="http://schemas.microsoft.com/office/drawing/2014/main" id="{65E4ADB5-62EB-4AC4-A56F-91AA659BD487}"/>
              </a:ext>
            </a:extLst>
          </p:cNvPr>
          <p:cNvGrpSpPr/>
          <p:nvPr/>
        </p:nvGrpSpPr>
        <p:grpSpPr>
          <a:xfrm>
            <a:off x="6095999" y="6245387"/>
            <a:ext cx="3486745" cy="369332"/>
            <a:chOff x="7747798" y="6312499"/>
            <a:chExt cx="3486745" cy="369332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B59DC06-18D4-4630-9153-A75E81201426}"/>
                </a:ext>
              </a:extLst>
            </p:cNvPr>
            <p:cNvSpPr txBox="1"/>
            <p:nvPr/>
          </p:nvSpPr>
          <p:spPr>
            <a:xfrm>
              <a:off x="7855798" y="6312499"/>
              <a:ext cx="337874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Predicted leaf photosynthesis rate</a:t>
              </a:r>
            </a:p>
          </p:txBody>
        </p:sp>
        <p:sp>
          <p:nvSpPr>
            <p:cNvPr id="11" name="Oval 10">
              <a:extLst>
                <a:ext uri="{FF2B5EF4-FFF2-40B4-BE49-F238E27FC236}">
                  <a16:creationId xmlns:a16="http://schemas.microsoft.com/office/drawing/2014/main" id="{4BC7E0D0-80BE-4F53-9068-5110E706B178}"/>
                </a:ext>
              </a:extLst>
            </p:cNvPr>
            <p:cNvSpPr/>
            <p:nvPr/>
          </p:nvSpPr>
          <p:spPr>
            <a:xfrm>
              <a:off x="7747798" y="6443165"/>
              <a:ext cx="108000" cy="108000"/>
            </a:xfrm>
            <a:prstGeom prst="ellipse">
              <a:avLst/>
            </a:prstGeom>
            <a:noFill/>
            <a:ln>
              <a:solidFill>
                <a:srgbClr val="1205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8AD511A2-4552-4C82-ACA9-D052977D5267}"/>
              </a:ext>
            </a:extLst>
          </p:cNvPr>
          <p:cNvSpPr txBox="1"/>
          <p:nvPr/>
        </p:nvSpPr>
        <p:spPr>
          <a:xfrm>
            <a:off x="2169460" y="6245387"/>
            <a:ext cx="36008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FF0000"/>
                </a:solidFill>
              </a:rPr>
              <a:t>+</a:t>
            </a:r>
            <a:r>
              <a:rPr lang="en-GB" dirty="0"/>
              <a:t> Measured leaf photosynthesis rat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6771ED5-9640-4664-886E-3C8DC3F17B47}"/>
              </a:ext>
            </a:extLst>
          </p:cNvPr>
          <p:cNvSpPr txBox="1"/>
          <p:nvPr/>
        </p:nvSpPr>
        <p:spPr>
          <a:xfrm>
            <a:off x="562062" y="1300294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14695AC-617A-4C53-995F-62E08BA63F4A}"/>
              </a:ext>
            </a:extLst>
          </p:cNvPr>
          <p:cNvSpPr txBox="1"/>
          <p:nvPr/>
        </p:nvSpPr>
        <p:spPr>
          <a:xfrm>
            <a:off x="4560611" y="1302325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62CBF08-8929-4866-AD48-8063988139A1}"/>
              </a:ext>
            </a:extLst>
          </p:cNvPr>
          <p:cNvSpPr txBox="1"/>
          <p:nvPr/>
        </p:nvSpPr>
        <p:spPr>
          <a:xfrm>
            <a:off x="8559160" y="1300294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53AE25A-C632-4DC6-884D-93C00E64CC0A}"/>
              </a:ext>
            </a:extLst>
          </p:cNvPr>
          <p:cNvSpPr txBox="1"/>
          <p:nvPr/>
        </p:nvSpPr>
        <p:spPr>
          <a:xfrm>
            <a:off x="554967" y="3760446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4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10CDA54-2DA5-4B58-809E-0CE163D40E5F}"/>
              </a:ext>
            </a:extLst>
          </p:cNvPr>
          <p:cNvSpPr txBox="1"/>
          <p:nvPr/>
        </p:nvSpPr>
        <p:spPr>
          <a:xfrm>
            <a:off x="4553516" y="3762477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5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5B33F1B-B0D0-46E7-869A-890B10A57BA7}"/>
              </a:ext>
            </a:extLst>
          </p:cNvPr>
          <p:cNvSpPr txBox="1"/>
          <p:nvPr/>
        </p:nvSpPr>
        <p:spPr>
          <a:xfrm>
            <a:off x="8552065" y="3760446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6</a:t>
            </a:r>
          </a:p>
        </p:txBody>
      </p:sp>
    </p:spTree>
    <p:extLst>
      <p:ext uri="{BB962C8B-B14F-4D97-AF65-F5344CB8AC3E}">
        <p14:creationId xmlns:p14="http://schemas.microsoft.com/office/powerpoint/2010/main" val="21494819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>
            <a:extLst>
              <a:ext uri="{FF2B5EF4-FFF2-40B4-BE49-F238E27FC236}">
                <a16:creationId xmlns:a16="http://schemas.microsoft.com/office/drawing/2014/main" id="{29A2D333-AD82-480B-93A9-B5A0BCE603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400" y="944059"/>
            <a:ext cx="3998548" cy="270000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6B0E65B2-632D-424F-86B6-02F3148C7DC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58948" y="944059"/>
            <a:ext cx="3998548" cy="270000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2AF87A0E-2D29-4C8F-9E35-90662CC951E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57495" y="944059"/>
            <a:ext cx="3998548" cy="270000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ABD43E1B-6E0F-4DEA-9A38-971D4358916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0400" y="3429000"/>
            <a:ext cx="3998548" cy="2700000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F5F8DDDC-60A8-4A43-A32D-5175097EB7E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58948" y="3429000"/>
            <a:ext cx="3998548" cy="2700000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B3C3C154-FAEE-401A-B7F4-AAAE8C76859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157495" y="3429000"/>
            <a:ext cx="3998548" cy="2700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4F537812-CB6C-48B1-BE0C-240847DA3746}"/>
              </a:ext>
            </a:extLst>
          </p:cNvPr>
          <p:cNvSpPr txBox="1"/>
          <p:nvPr/>
        </p:nvSpPr>
        <p:spPr>
          <a:xfrm>
            <a:off x="1543247" y="176169"/>
            <a:ext cx="910550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Examples of the comparisons between measured and predicted leaf net photosynthesis rate</a:t>
            </a:r>
          </a:p>
          <a:p>
            <a:endParaRPr lang="en-GB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D316B54-2979-4DCB-81F7-5391E8B80B8C}"/>
              </a:ext>
            </a:extLst>
          </p:cNvPr>
          <p:cNvSpPr txBox="1"/>
          <p:nvPr/>
        </p:nvSpPr>
        <p:spPr>
          <a:xfrm>
            <a:off x="4919330" y="583834"/>
            <a:ext cx="30714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hrysanthemum cv. ‘Anastasia’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65E4ADB5-62EB-4AC4-A56F-91AA659BD487}"/>
              </a:ext>
            </a:extLst>
          </p:cNvPr>
          <p:cNvGrpSpPr/>
          <p:nvPr/>
        </p:nvGrpSpPr>
        <p:grpSpPr>
          <a:xfrm>
            <a:off x="6095999" y="6245387"/>
            <a:ext cx="3486745" cy="369332"/>
            <a:chOff x="7747798" y="6312499"/>
            <a:chExt cx="3486745" cy="369332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B59DC06-18D4-4630-9153-A75E81201426}"/>
                </a:ext>
              </a:extLst>
            </p:cNvPr>
            <p:cNvSpPr txBox="1"/>
            <p:nvPr/>
          </p:nvSpPr>
          <p:spPr>
            <a:xfrm>
              <a:off x="7855798" y="6312499"/>
              <a:ext cx="337874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Predicted leaf photosynthesis rate</a:t>
              </a:r>
            </a:p>
          </p:txBody>
        </p:sp>
        <p:sp>
          <p:nvSpPr>
            <p:cNvPr id="11" name="Oval 10">
              <a:extLst>
                <a:ext uri="{FF2B5EF4-FFF2-40B4-BE49-F238E27FC236}">
                  <a16:creationId xmlns:a16="http://schemas.microsoft.com/office/drawing/2014/main" id="{4BC7E0D0-80BE-4F53-9068-5110E706B178}"/>
                </a:ext>
              </a:extLst>
            </p:cNvPr>
            <p:cNvSpPr/>
            <p:nvPr/>
          </p:nvSpPr>
          <p:spPr>
            <a:xfrm>
              <a:off x="7747798" y="6443165"/>
              <a:ext cx="108000" cy="108000"/>
            </a:xfrm>
            <a:prstGeom prst="ellipse">
              <a:avLst/>
            </a:prstGeom>
            <a:noFill/>
            <a:ln>
              <a:solidFill>
                <a:srgbClr val="1205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8AD511A2-4552-4C82-ACA9-D052977D5267}"/>
              </a:ext>
            </a:extLst>
          </p:cNvPr>
          <p:cNvSpPr txBox="1"/>
          <p:nvPr/>
        </p:nvSpPr>
        <p:spPr>
          <a:xfrm>
            <a:off x="2169460" y="6245387"/>
            <a:ext cx="36008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FF0000"/>
                </a:solidFill>
              </a:rPr>
              <a:t>+</a:t>
            </a:r>
            <a:r>
              <a:rPr lang="en-GB" dirty="0"/>
              <a:t> Measured leaf photosynthesis rat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6771ED5-9640-4664-886E-3C8DC3F17B47}"/>
              </a:ext>
            </a:extLst>
          </p:cNvPr>
          <p:cNvSpPr txBox="1"/>
          <p:nvPr/>
        </p:nvSpPr>
        <p:spPr>
          <a:xfrm>
            <a:off x="562062" y="1300294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14695AC-617A-4C53-995F-62E08BA63F4A}"/>
              </a:ext>
            </a:extLst>
          </p:cNvPr>
          <p:cNvSpPr txBox="1"/>
          <p:nvPr/>
        </p:nvSpPr>
        <p:spPr>
          <a:xfrm>
            <a:off x="4560611" y="1302325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62CBF08-8929-4866-AD48-8063988139A1}"/>
              </a:ext>
            </a:extLst>
          </p:cNvPr>
          <p:cNvSpPr txBox="1"/>
          <p:nvPr/>
        </p:nvSpPr>
        <p:spPr>
          <a:xfrm>
            <a:off x="8559160" y="1300294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53AE25A-C632-4DC6-884D-93C00E64CC0A}"/>
              </a:ext>
            </a:extLst>
          </p:cNvPr>
          <p:cNvSpPr txBox="1"/>
          <p:nvPr/>
        </p:nvSpPr>
        <p:spPr>
          <a:xfrm>
            <a:off x="554967" y="3760446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4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10CDA54-2DA5-4B58-809E-0CE163D40E5F}"/>
              </a:ext>
            </a:extLst>
          </p:cNvPr>
          <p:cNvSpPr txBox="1"/>
          <p:nvPr/>
        </p:nvSpPr>
        <p:spPr>
          <a:xfrm>
            <a:off x="4553516" y="3762477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5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5B33F1B-B0D0-46E7-869A-890B10A57BA7}"/>
              </a:ext>
            </a:extLst>
          </p:cNvPr>
          <p:cNvSpPr txBox="1"/>
          <p:nvPr/>
        </p:nvSpPr>
        <p:spPr>
          <a:xfrm>
            <a:off x="8552065" y="3760446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6</a:t>
            </a:r>
          </a:p>
        </p:txBody>
      </p:sp>
    </p:spTree>
    <p:extLst>
      <p:ext uri="{BB962C8B-B14F-4D97-AF65-F5344CB8AC3E}">
        <p14:creationId xmlns:p14="http://schemas.microsoft.com/office/powerpoint/2010/main" val="17097212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>
            <a:extLst>
              <a:ext uri="{FF2B5EF4-FFF2-40B4-BE49-F238E27FC236}">
                <a16:creationId xmlns:a16="http://schemas.microsoft.com/office/drawing/2014/main" id="{89390CA1-25FF-4E44-987A-08AA32E0D85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400" y="944059"/>
            <a:ext cx="3998548" cy="270000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C5ECA20E-FF1D-431A-B460-44A1E756A09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58947" y="944059"/>
            <a:ext cx="3998548" cy="270000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E2C415E3-02E9-4BC2-AF4B-C2AA6E1F558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57495" y="944059"/>
            <a:ext cx="3998548" cy="270000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86C91656-2DA6-400B-B610-F20E87C3215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0400" y="3429000"/>
            <a:ext cx="3998548" cy="2700000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FD1F25B6-40AA-41DA-89DE-7D37414A5F3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58947" y="3429000"/>
            <a:ext cx="3998548" cy="2700000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D2B67C95-B0B3-49A2-93F4-D11581BA6DF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157495" y="3429000"/>
            <a:ext cx="3998548" cy="2700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4F537812-CB6C-48B1-BE0C-240847DA3746}"/>
              </a:ext>
            </a:extLst>
          </p:cNvPr>
          <p:cNvSpPr txBox="1"/>
          <p:nvPr/>
        </p:nvSpPr>
        <p:spPr>
          <a:xfrm>
            <a:off x="1543247" y="176169"/>
            <a:ext cx="910550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Examples of the comparisons between measured and predicted leaf net photosynthesis rate</a:t>
            </a:r>
          </a:p>
          <a:p>
            <a:endParaRPr lang="en-GB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D316B54-2979-4DCB-81F7-5391E8B80B8C}"/>
              </a:ext>
            </a:extLst>
          </p:cNvPr>
          <p:cNvSpPr txBox="1"/>
          <p:nvPr/>
        </p:nvSpPr>
        <p:spPr>
          <a:xfrm>
            <a:off x="4919330" y="583834"/>
            <a:ext cx="21263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ose cv. ‘Red Naomi’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65E4ADB5-62EB-4AC4-A56F-91AA659BD487}"/>
              </a:ext>
            </a:extLst>
          </p:cNvPr>
          <p:cNvGrpSpPr/>
          <p:nvPr/>
        </p:nvGrpSpPr>
        <p:grpSpPr>
          <a:xfrm>
            <a:off x="6095999" y="6245387"/>
            <a:ext cx="3486745" cy="369332"/>
            <a:chOff x="7747798" y="6312499"/>
            <a:chExt cx="3486745" cy="369332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B59DC06-18D4-4630-9153-A75E81201426}"/>
                </a:ext>
              </a:extLst>
            </p:cNvPr>
            <p:cNvSpPr txBox="1"/>
            <p:nvPr/>
          </p:nvSpPr>
          <p:spPr>
            <a:xfrm>
              <a:off x="7855798" y="6312499"/>
              <a:ext cx="337874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Predicted leaf photosynthesis rate</a:t>
              </a:r>
            </a:p>
          </p:txBody>
        </p:sp>
        <p:sp>
          <p:nvSpPr>
            <p:cNvPr id="11" name="Oval 10">
              <a:extLst>
                <a:ext uri="{FF2B5EF4-FFF2-40B4-BE49-F238E27FC236}">
                  <a16:creationId xmlns:a16="http://schemas.microsoft.com/office/drawing/2014/main" id="{4BC7E0D0-80BE-4F53-9068-5110E706B178}"/>
                </a:ext>
              </a:extLst>
            </p:cNvPr>
            <p:cNvSpPr/>
            <p:nvPr/>
          </p:nvSpPr>
          <p:spPr>
            <a:xfrm>
              <a:off x="7747798" y="6443165"/>
              <a:ext cx="108000" cy="108000"/>
            </a:xfrm>
            <a:prstGeom prst="ellipse">
              <a:avLst/>
            </a:prstGeom>
            <a:noFill/>
            <a:ln>
              <a:solidFill>
                <a:srgbClr val="1205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8AD511A2-4552-4C82-ACA9-D052977D5267}"/>
              </a:ext>
            </a:extLst>
          </p:cNvPr>
          <p:cNvSpPr txBox="1"/>
          <p:nvPr/>
        </p:nvSpPr>
        <p:spPr>
          <a:xfrm>
            <a:off x="2169460" y="6245387"/>
            <a:ext cx="36008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FF0000"/>
                </a:solidFill>
              </a:rPr>
              <a:t>+</a:t>
            </a:r>
            <a:r>
              <a:rPr lang="en-GB" dirty="0"/>
              <a:t> Measured leaf photosynthesis rat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6771ED5-9640-4664-886E-3C8DC3F17B47}"/>
              </a:ext>
            </a:extLst>
          </p:cNvPr>
          <p:cNvSpPr txBox="1"/>
          <p:nvPr/>
        </p:nvSpPr>
        <p:spPr>
          <a:xfrm>
            <a:off x="562062" y="1300294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14695AC-617A-4C53-995F-62E08BA63F4A}"/>
              </a:ext>
            </a:extLst>
          </p:cNvPr>
          <p:cNvSpPr txBox="1"/>
          <p:nvPr/>
        </p:nvSpPr>
        <p:spPr>
          <a:xfrm>
            <a:off x="4560611" y="1302325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62CBF08-8929-4866-AD48-8063988139A1}"/>
              </a:ext>
            </a:extLst>
          </p:cNvPr>
          <p:cNvSpPr txBox="1"/>
          <p:nvPr/>
        </p:nvSpPr>
        <p:spPr>
          <a:xfrm>
            <a:off x="8559160" y="1300294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53AE25A-C632-4DC6-884D-93C00E64CC0A}"/>
              </a:ext>
            </a:extLst>
          </p:cNvPr>
          <p:cNvSpPr txBox="1"/>
          <p:nvPr/>
        </p:nvSpPr>
        <p:spPr>
          <a:xfrm>
            <a:off x="554967" y="3760446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4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10CDA54-2DA5-4B58-809E-0CE163D40E5F}"/>
              </a:ext>
            </a:extLst>
          </p:cNvPr>
          <p:cNvSpPr txBox="1"/>
          <p:nvPr/>
        </p:nvSpPr>
        <p:spPr>
          <a:xfrm>
            <a:off x="4553516" y="3762477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5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5B33F1B-B0D0-46E7-869A-890B10A57BA7}"/>
              </a:ext>
            </a:extLst>
          </p:cNvPr>
          <p:cNvSpPr txBox="1"/>
          <p:nvPr/>
        </p:nvSpPr>
        <p:spPr>
          <a:xfrm>
            <a:off x="8552065" y="3760446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6</a:t>
            </a:r>
          </a:p>
        </p:txBody>
      </p:sp>
    </p:spTree>
    <p:extLst>
      <p:ext uri="{BB962C8B-B14F-4D97-AF65-F5344CB8AC3E}">
        <p14:creationId xmlns:p14="http://schemas.microsoft.com/office/powerpoint/2010/main" val="275500470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BB6DC3F-EBB0-401B-8D8E-0E3BCDDB318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57495" y="3429000"/>
            <a:ext cx="3998548" cy="2700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BCE9474-8875-4B3E-95D9-C16F2699CA2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58947" y="3429000"/>
            <a:ext cx="3998548" cy="2700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525A895A-896E-499B-A0A9-A55CC8CEE09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0400" y="3429000"/>
            <a:ext cx="3998548" cy="2700000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E1389DE7-D46D-495A-A10A-8A7C496A8FE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57494" y="944059"/>
            <a:ext cx="3998548" cy="2700000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06E511B3-014B-410E-8463-B494604340C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58947" y="944059"/>
            <a:ext cx="3998548" cy="2700000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F3F7748C-FC1B-422C-8AD1-300516B0132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60400" y="944059"/>
            <a:ext cx="3998548" cy="2700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4F537812-CB6C-48B1-BE0C-240847DA3746}"/>
              </a:ext>
            </a:extLst>
          </p:cNvPr>
          <p:cNvSpPr txBox="1"/>
          <p:nvPr/>
        </p:nvSpPr>
        <p:spPr>
          <a:xfrm>
            <a:off x="1543247" y="176169"/>
            <a:ext cx="910550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Examples of the comparisons between measured and predicted leaf net photosynthesis rate</a:t>
            </a:r>
          </a:p>
          <a:p>
            <a:endParaRPr lang="en-GB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D316B54-2979-4DCB-81F7-5391E8B80B8C}"/>
              </a:ext>
            </a:extLst>
          </p:cNvPr>
          <p:cNvSpPr txBox="1"/>
          <p:nvPr/>
        </p:nvSpPr>
        <p:spPr>
          <a:xfrm>
            <a:off x="4919330" y="583834"/>
            <a:ext cx="1591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asil cv. ‘Emily’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65E4ADB5-62EB-4AC4-A56F-91AA659BD487}"/>
              </a:ext>
            </a:extLst>
          </p:cNvPr>
          <p:cNvGrpSpPr/>
          <p:nvPr/>
        </p:nvGrpSpPr>
        <p:grpSpPr>
          <a:xfrm>
            <a:off x="6095999" y="6245387"/>
            <a:ext cx="3486745" cy="369332"/>
            <a:chOff x="7747798" y="6312499"/>
            <a:chExt cx="3486745" cy="369332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B59DC06-18D4-4630-9153-A75E81201426}"/>
                </a:ext>
              </a:extLst>
            </p:cNvPr>
            <p:cNvSpPr txBox="1"/>
            <p:nvPr/>
          </p:nvSpPr>
          <p:spPr>
            <a:xfrm>
              <a:off x="7855798" y="6312499"/>
              <a:ext cx="337874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Predicted leaf photosynthesis rate</a:t>
              </a:r>
            </a:p>
          </p:txBody>
        </p:sp>
        <p:sp>
          <p:nvSpPr>
            <p:cNvPr id="11" name="Oval 10">
              <a:extLst>
                <a:ext uri="{FF2B5EF4-FFF2-40B4-BE49-F238E27FC236}">
                  <a16:creationId xmlns:a16="http://schemas.microsoft.com/office/drawing/2014/main" id="{4BC7E0D0-80BE-4F53-9068-5110E706B178}"/>
                </a:ext>
              </a:extLst>
            </p:cNvPr>
            <p:cNvSpPr/>
            <p:nvPr/>
          </p:nvSpPr>
          <p:spPr>
            <a:xfrm>
              <a:off x="7747798" y="6443165"/>
              <a:ext cx="108000" cy="108000"/>
            </a:xfrm>
            <a:prstGeom prst="ellipse">
              <a:avLst/>
            </a:prstGeom>
            <a:noFill/>
            <a:ln>
              <a:solidFill>
                <a:srgbClr val="1205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8AD511A2-4552-4C82-ACA9-D052977D5267}"/>
              </a:ext>
            </a:extLst>
          </p:cNvPr>
          <p:cNvSpPr txBox="1"/>
          <p:nvPr/>
        </p:nvSpPr>
        <p:spPr>
          <a:xfrm>
            <a:off x="2169460" y="6245387"/>
            <a:ext cx="36008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FF0000"/>
                </a:solidFill>
              </a:rPr>
              <a:t>+</a:t>
            </a:r>
            <a:r>
              <a:rPr lang="en-GB" dirty="0"/>
              <a:t> Measured leaf photosynthesis rat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6771ED5-9640-4664-886E-3C8DC3F17B47}"/>
              </a:ext>
            </a:extLst>
          </p:cNvPr>
          <p:cNvSpPr txBox="1"/>
          <p:nvPr/>
        </p:nvSpPr>
        <p:spPr>
          <a:xfrm>
            <a:off x="562062" y="1300294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14695AC-617A-4C53-995F-62E08BA63F4A}"/>
              </a:ext>
            </a:extLst>
          </p:cNvPr>
          <p:cNvSpPr txBox="1"/>
          <p:nvPr/>
        </p:nvSpPr>
        <p:spPr>
          <a:xfrm>
            <a:off x="4560611" y="1302325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62CBF08-8929-4866-AD48-8063988139A1}"/>
              </a:ext>
            </a:extLst>
          </p:cNvPr>
          <p:cNvSpPr txBox="1"/>
          <p:nvPr/>
        </p:nvSpPr>
        <p:spPr>
          <a:xfrm>
            <a:off x="8559160" y="1300294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53AE25A-C632-4DC6-884D-93C00E64CC0A}"/>
              </a:ext>
            </a:extLst>
          </p:cNvPr>
          <p:cNvSpPr txBox="1"/>
          <p:nvPr/>
        </p:nvSpPr>
        <p:spPr>
          <a:xfrm>
            <a:off x="554967" y="3760446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4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10CDA54-2DA5-4B58-809E-0CE163D40E5F}"/>
              </a:ext>
            </a:extLst>
          </p:cNvPr>
          <p:cNvSpPr txBox="1"/>
          <p:nvPr/>
        </p:nvSpPr>
        <p:spPr>
          <a:xfrm>
            <a:off x="4553516" y="3762477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5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5B33F1B-B0D0-46E7-869A-890B10A57BA7}"/>
              </a:ext>
            </a:extLst>
          </p:cNvPr>
          <p:cNvSpPr txBox="1"/>
          <p:nvPr/>
        </p:nvSpPr>
        <p:spPr>
          <a:xfrm>
            <a:off x="8552065" y="3760446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6</a:t>
            </a:r>
          </a:p>
        </p:txBody>
      </p:sp>
    </p:spTree>
    <p:extLst>
      <p:ext uri="{BB962C8B-B14F-4D97-AF65-F5344CB8AC3E}">
        <p14:creationId xmlns:p14="http://schemas.microsoft.com/office/powerpoint/2010/main" val="2144733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525B2681-DADA-46DB-8FB0-73007745E1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50500" y="3429000"/>
            <a:ext cx="3998548" cy="270000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32A77F3E-11CE-4FCC-B0CA-D902B658877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55450" y="3429000"/>
            <a:ext cx="3998548" cy="2700000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760167E8-555D-4D1A-843F-089F54BDC5B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0400" y="3429000"/>
            <a:ext cx="3998548" cy="270000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20261065-60A3-4796-806A-81B6F49FA3C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50500" y="944059"/>
            <a:ext cx="3998548" cy="2700000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6E22AD89-A961-43BA-9DD3-DC9F9D1AF09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55450" y="944059"/>
            <a:ext cx="3998548" cy="2700000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4BC3A960-4717-4453-A975-CE2D0FFC882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60400" y="944059"/>
            <a:ext cx="3998548" cy="2700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4F537812-CB6C-48B1-BE0C-240847DA3746}"/>
              </a:ext>
            </a:extLst>
          </p:cNvPr>
          <p:cNvSpPr txBox="1"/>
          <p:nvPr/>
        </p:nvSpPr>
        <p:spPr>
          <a:xfrm>
            <a:off x="1543247" y="176169"/>
            <a:ext cx="910550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Examples of the comparisons between measured and predicted leaf net photosynthesis rate</a:t>
            </a:r>
          </a:p>
          <a:p>
            <a:endParaRPr lang="en-GB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D316B54-2979-4DCB-81F7-5391E8B80B8C}"/>
              </a:ext>
            </a:extLst>
          </p:cNvPr>
          <p:cNvSpPr txBox="1"/>
          <p:nvPr/>
        </p:nvSpPr>
        <p:spPr>
          <a:xfrm>
            <a:off x="4919330" y="583834"/>
            <a:ext cx="20906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Lettuce cv. ‘Gilmore’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65E4ADB5-62EB-4AC4-A56F-91AA659BD487}"/>
              </a:ext>
            </a:extLst>
          </p:cNvPr>
          <p:cNvGrpSpPr/>
          <p:nvPr/>
        </p:nvGrpSpPr>
        <p:grpSpPr>
          <a:xfrm>
            <a:off x="6095999" y="6245387"/>
            <a:ext cx="3486745" cy="369332"/>
            <a:chOff x="7747798" y="6312499"/>
            <a:chExt cx="3486745" cy="369332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B59DC06-18D4-4630-9153-A75E81201426}"/>
                </a:ext>
              </a:extLst>
            </p:cNvPr>
            <p:cNvSpPr txBox="1"/>
            <p:nvPr/>
          </p:nvSpPr>
          <p:spPr>
            <a:xfrm>
              <a:off x="7855798" y="6312499"/>
              <a:ext cx="337874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Predicted leaf photosynthesis rate</a:t>
              </a:r>
            </a:p>
          </p:txBody>
        </p:sp>
        <p:sp>
          <p:nvSpPr>
            <p:cNvPr id="11" name="Oval 10">
              <a:extLst>
                <a:ext uri="{FF2B5EF4-FFF2-40B4-BE49-F238E27FC236}">
                  <a16:creationId xmlns:a16="http://schemas.microsoft.com/office/drawing/2014/main" id="{4BC7E0D0-80BE-4F53-9068-5110E706B178}"/>
                </a:ext>
              </a:extLst>
            </p:cNvPr>
            <p:cNvSpPr/>
            <p:nvPr/>
          </p:nvSpPr>
          <p:spPr>
            <a:xfrm>
              <a:off x="7747798" y="6443165"/>
              <a:ext cx="108000" cy="108000"/>
            </a:xfrm>
            <a:prstGeom prst="ellipse">
              <a:avLst/>
            </a:prstGeom>
            <a:noFill/>
            <a:ln>
              <a:solidFill>
                <a:srgbClr val="1205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8AD511A2-4552-4C82-ACA9-D052977D5267}"/>
              </a:ext>
            </a:extLst>
          </p:cNvPr>
          <p:cNvSpPr txBox="1"/>
          <p:nvPr/>
        </p:nvSpPr>
        <p:spPr>
          <a:xfrm>
            <a:off x="2169460" y="6245387"/>
            <a:ext cx="36008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FF0000"/>
                </a:solidFill>
              </a:rPr>
              <a:t>+</a:t>
            </a:r>
            <a:r>
              <a:rPr lang="en-GB" dirty="0"/>
              <a:t> Measured leaf photosynthesis rat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6771ED5-9640-4664-886E-3C8DC3F17B47}"/>
              </a:ext>
            </a:extLst>
          </p:cNvPr>
          <p:cNvSpPr txBox="1"/>
          <p:nvPr/>
        </p:nvSpPr>
        <p:spPr>
          <a:xfrm>
            <a:off x="562062" y="1300294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14695AC-617A-4C53-995F-62E08BA63F4A}"/>
              </a:ext>
            </a:extLst>
          </p:cNvPr>
          <p:cNvSpPr txBox="1"/>
          <p:nvPr/>
        </p:nvSpPr>
        <p:spPr>
          <a:xfrm>
            <a:off x="4560611" y="1302325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62CBF08-8929-4866-AD48-8063988139A1}"/>
              </a:ext>
            </a:extLst>
          </p:cNvPr>
          <p:cNvSpPr txBox="1"/>
          <p:nvPr/>
        </p:nvSpPr>
        <p:spPr>
          <a:xfrm>
            <a:off x="8559160" y="1300294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53AE25A-C632-4DC6-884D-93C00E64CC0A}"/>
              </a:ext>
            </a:extLst>
          </p:cNvPr>
          <p:cNvSpPr txBox="1"/>
          <p:nvPr/>
        </p:nvSpPr>
        <p:spPr>
          <a:xfrm>
            <a:off x="554967" y="3760446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4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10CDA54-2DA5-4B58-809E-0CE163D40E5F}"/>
              </a:ext>
            </a:extLst>
          </p:cNvPr>
          <p:cNvSpPr txBox="1"/>
          <p:nvPr/>
        </p:nvSpPr>
        <p:spPr>
          <a:xfrm>
            <a:off x="4553516" y="3762477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5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5B33F1B-B0D0-46E7-869A-890B10A57BA7}"/>
              </a:ext>
            </a:extLst>
          </p:cNvPr>
          <p:cNvSpPr txBox="1"/>
          <p:nvPr/>
        </p:nvSpPr>
        <p:spPr>
          <a:xfrm>
            <a:off x="8552065" y="3760446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6</a:t>
            </a:r>
          </a:p>
        </p:txBody>
      </p:sp>
    </p:spTree>
    <p:extLst>
      <p:ext uri="{BB962C8B-B14F-4D97-AF65-F5344CB8AC3E}">
        <p14:creationId xmlns:p14="http://schemas.microsoft.com/office/powerpoint/2010/main" val="17254078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</TotalTime>
  <Words>235</Words>
  <Application>Microsoft Office PowerPoint</Application>
  <PresentationFormat>Widescreen</PresentationFormat>
  <Paragraphs>60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ng, Ningyi</dc:creator>
  <cp:lastModifiedBy>Zhang, Ningyi</cp:lastModifiedBy>
  <cp:revision>8</cp:revision>
  <dcterms:created xsi:type="dcterms:W3CDTF">2022-03-01T15:38:46Z</dcterms:created>
  <dcterms:modified xsi:type="dcterms:W3CDTF">2022-03-01T16:27:26Z</dcterms:modified>
</cp:coreProperties>
</file>